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3969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49" autoAdjust="0"/>
    <p:restoredTop sz="94660"/>
  </p:normalViewPr>
  <p:slideViewPr>
    <p:cSldViewPr snapToGrid="0">
      <p:cViewPr varScale="1">
        <p:scale>
          <a:sx n="82" d="100"/>
          <a:sy n="82" d="100"/>
        </p:scale>
        <p:origin x="69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fection prophylaxis following anti-CD20 monoclonal antibodies in childhood kidney diseas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Zhou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Effective infection prophylaxis in children receiving anti-CD20 mAbs requires infection risk awareness, timely vaccination and prophylaxis guided by B-cell status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95582" y="1203715"/>
            <a:ext cx="7584275" cy="4462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pPr marL="342900" indent="-342900">
              <a:spcAft>
                <a:spcPts val="1200"/>
              </a:spcAft>
              <a:buFont typeface="+mj-lt"/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Anti-CD20 mAbs are increasingly used in the management of childhood kidney diseases, yet there are concerns about their side effects, especially infection.</a:t>
            </a:r>
          </a:p>
          <a:p>
            <a:pPr marL="342900" indent="-342900">
              <a:spcAft>
                <a:spcPts val="1200"/>
              </a:spcAft>
              <a:buFont typeface="+mj-lt"/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A structured approach should be adopted to assess and mitigate infection risk in children receiving anti-CD20 mAbs.</a:t>
            </a:r>
          </a:p>
          <a:p>
            <a:pPr marL="342900" indent="-342900">
              <a:spcAft>
                <a:spcPts val="1200"/>
              </a:spcAft>
              <a:buFont typeface="+mj-lt"/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In addition, monitoring for neutropenia and hypogammaglobulinaemia, antimicrobial prophylaxis, immunisation, and the modification of risk factors should be considered to optimise safety in children receiving anti-CD20 mAbs.</a:t>
            </a:r>
          </a:p>
          <a:p>
            <a:pPr marL="342900" indent="-342900">
              <a:spcAft>
                <a:spcPts val="1200"/>
              </a:spcAft>
              <a:buFont typeface="+mj-lt"/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Further prospective, large cohort paediatric studies, particularly for new generations of anti-CD20 mAbs, are warranted to explore their infection risks and refine prophylaxis strategies.</a:t>
            </a:r>
          </a:p>
        </p:txBody>
      </p:sp>
      <p:pic>
        <p:nvPicPr>
          <p:cNvPr id="42" name="Picture 41" descr="A diagram of a practice points&#10;&#10;AI-generated content may be incorrect.">
            <a:extLst>
              <a:ext uri="{FF2B5EF4-FFF2-40B4-BE49-F238E27FC236}">
                <a16:creationId xmlns:a16="http://schemas.microsoft.com/office/drawing/2014/main" id="{AD992165-E019-8BCA-CB11-609303CBC5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2861" y="1203715"/>
            <a:ext cx="4663557" cy="4239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9</TotalTime>
  <Words>147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7</cp:revision>
  <dcterms:created xsi:type="dcterms:W3CDTF">2019-06-13T12:30:18Z</dcterms:created>
  <dcterms:modified xsi:type="dcterms:W3CDTF">2026-01-20T22:48:20Z</dcterms:modified>
</cp:coreProperties>
</file>